
<file path=[Content_Types].xml><?xml version="1.0" encoding="utf-8"?>
<Types xmlns="http://schemas.openxmlformats.org/package/2006/content-types">
  <Default Extension="png" ContentType="image/pn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367" r:id="rId2"/>
    <p:sldId id="368" r:id="rId3"/>
    <p:sldId id="371" r:id="rId4"/>
    <p:sldId id="372" r:id="rId5"/>
    <p:sldId id="370" r:id="rId6"/>
    <p:sldId id="366" r:id="rId7"/>
  </p:sldIdLst>
  <p:sldSz cx="6858000" cy="9144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arald Rouha" initials="HR" lastIdx="1" clrIdx="0">
    <p:extLst/>
  </p:cmAuthor>
  <p:cmAuthor id="2" name="philipp.janesch" initials="p" lastIdx="16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  <a:srgbClr val="171C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1" autoAdjust="0"/>
    <p:restoredTop sz="94660"/>
  </p:normalViewPr>
  <p:slideViewPr>
    <p:cSldViewPr>
      <p:cViewPr varScale="1">
        <p:scale>
          <a:sx n="53" d="100"/>
          <a:sy n="53" d="100"/>
        </p:scale>
        <p:origin x="221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36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9" y="5"/>
            <a:ext cx="3076363" cy="511731"/>
          </a:xfrm>
          <a:prstGeom prst="rect">
            <a:avLst/>
          </a:prstGeom>
        </p:spPr>
        <p:txBody>
          <a:bodyPr vert="horz" lIns="94723" tIns="47361" rIns="94723" bIns="47361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304" y="5"/>
            <a:ext cx="3076363" cy="511731"/>
          </a:xfrm>
          <a:prstGeom prst="rect">
            <a:avLst/>
          </a:prstGeom>
        </p:spPr>
        <p:txBody>
          <a:bodyPr vert="horz" lIns="94723" tIns="47361" rIns="94723" bIns="47361" rtlCol="0"/>
          <a:lstStyle>
            <a:lvl1pPr algn="r">
              <a:defRPr sz="1200"/>
            </a:lvl1pPr>
          </a:lstStyle>
          <a:p>
            <a:fld id="{2E48AAC2-F203-4F35-AB22-4F1DA8A4FC30}" type="datetimeFigureOut">
              <a:rPr lang="de-AT" smtClean="0"/>
              <a:t>05.10.2017</a:t>
            </a:fld>
            <a:endParaRPr lang="de-A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23" tIns="47361" rIns="94723" bIns="47361" rtlCol="0" anchor="ctr"/>
          <a:lstStyle/>
          <a:p>
            <a:endParaRPr lang="de-A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2" y="4861445"/>
            <a:ext cx="5679440" cy="4605576"/>
          </a:xfrm>
          <a:prstGeom prst="rect">
            <a:avLst/>
          </a:prstGeom>
        </p:spPr>
        <p:txBody>
          <a:bodyPr vert="horz" lIns="94723" tIns="47361" rIns="94723" bIns="4736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9" y="9721110"/>
            <a:ext cx="3076363" cy="511731"/>
          </a:xfrm>
          <a:prstGeom prst="rect">
            <a:avLst/>
          </a:prstGeom>
        </p:spPr>
        <p:txBody>
          <a:bodyPr vert="horz" lIns="94723" tIns="47361" rIns="94723" bIns="47361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304" y="9721110"/>
            <a:ext cx="3076363" cy="511731"/>
          </a:xfrm>
          <a:prstGeom prst="rect">
            <a:avLst/>
          </a:prstGeom>
        </p:spPr>
        <p:txBody>
          <a:bodyPr vert="horz" lIns="94723" tIns="47361" rIns="94723" bIns="47361" rtlCol="0" anchor="b"/>
          <a:lstStyle>
            <a:lvl1pPr algn="r">
              <a:defRPr sz="1200"/>
            </a:lvl1pPr>
          </a:lstStyle>
          <a:p>
            <a:fld id="{CF66B1AE-431C-457E-925F-005CA2A429A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36039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5578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684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818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1696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58953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3431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700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9975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5298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6990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7427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A54CB-91ED-481C-BAB3-1CA06695989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5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8BB871-ADF5-4651-8CA0-0331576D0E1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4908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717436" y="22315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600" dirty="0" smtClean="0">
                <a:solidFill>
                  <a:prstClr val="white">
                    <a:lumMod val="65000"/>
                  </a:prstClr>
                </a:solidFill>
                <a:latin typeface="Arial" pitchFamily="34" charset="0"/>
                <a:cs typeface="Arial" pitchFamily="34" charset="0"/>
              </a:rPr>
              <a:t>Figure S1</a:t>
            </a:r>
            <a:endParaRPr lang="de-AT" sz="1600" dirty="0">
              <a:solidFill>
                <a:prstClr val="white">
                  <a:lumMod val="65000"/>
                </a:prst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20610" y="4644010"/>
            <a:ext cx="5760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curves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btained with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ureus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 in different cult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nigh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ra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a sing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ny in the indicated media 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lu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OD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00n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.03 and grown to stationary phase for 8h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10" y="591740"/>
            <a:ext cx="4176580" cy="3862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0581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717436" y="22315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600" dirty="0" smtClean="0">
                <a:solidFill>
                  <a:prstClr val="white">
                    <a:lumMod val="65000"/>
                  </a:prstClr>
                </a:solidFill>
                <a:latin typeface="Arial" pitchFamily="34" charset="0"/>
                <a:cs typeface="Arial" pitchFamily="34" charset="0"/>
              </a:rPr>
              <a:t>Figure S2</a:t>
            </a:r>
            <a:endParaRPr lang="de-AT" sz="1600" dirty="0">
              <a:solidFill>
                <a:prstClr val="white">
                  <a:lumMod val="65000"/>
                </a:prst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339716" y="965416"/>
            <a:ext cx="2313454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6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inical Isolate LA#66 – ST5-II-t002 (MRSA, </a:t>
            </a:r>
            <a:r>
              <a:rPr lang="de-AT" sz="650" b="1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kSF-PV</a:t>
            </a:r>
            <a:r>
              <a:rPr lang="de-AT" sz="6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)</a:t>
            </a:r>
            <a:endParaRPr lang="en-US" sz="65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947587" y="1125045"/>
            <a:ext cx="496869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348850" y="2051650"/>
            <a:ext cx="2282997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6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inical Isolate LA#48 – ST45-t040 (</a:t>
            </a:r>
            <a:r>
              <a:rPr lang="de-AT" sz="6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SA</a:t>
            </a:r>
            <a:r>
              <a:rPr lang="de-AT" sz="65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AT" sz="650" b="1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kSF-PV</a:t>
            </a:r>
            <a:r>
              <a:rPr lang="de-AT" sz="6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)</a:t>
            </a:r>
            <a:endParaRPr lang="en-US" sz="65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992270" y="2211279"/>
            <a:ext cx="496869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350937" y="3131800"/>
            <a:ext cx="2302233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6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inical Isolate LA#132 – ST72t148 (</a:t>
            </a:r>
            <a:r>
              <a:rPr lang="de-AT" sz="6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SA, </a:t>
            </a:r>
            <a:r>
              <a:rPr lang="de-AT" sz="65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kSF-PV</a:t>
            </a:r>
            <a:r>
              <a:rPr lang="de-AT" sz="6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)</a:t>
            </a:r>
            <a:endParaRPr lang="en-US" sz="65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966637" y="3291429"/>
            <a:ext cx="496869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619389" y="4211950"/>
            <a:ext cx="1601721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6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9 – CC10/H10 (MRSA</a:t>
            </a:r>
            <a:r>
              <a:rPr lang="de-AT" sz="6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AT" sz="65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kSF-</a:t>
            </a:r>
            <a:r>
              <a:rPr lang="de-AT" sz="6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-) </a:t>
            </a:r>
            <a:endParaRPr lang="en-US" sz="65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>
            <a:off x="966637" y="4371579"/>
            <a:ext cx="496869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>
            <a:off x="620610" y="5580140"/>
            <a:ext cx="5760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stic effect of ASN-1 and ASN-2 in neutralizing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lture supernatants (CS) generated in different media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generated with a 16x diluted CS and 1 µM mAb concentration. Data are shown as mean +/- SEM of three independent experiments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958" y="1124940"/>
            <a:ext cx="5309302" cy="95818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781" y="2160245"/>
            <a:ext cx="5312785" cy="95954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586" y="3247858"/>
            <a:ext cx="5345805" cy="96409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395" y="4316285"/>
            <a:ext cx="5393493" cy="1181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6100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17436" y="22315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600" dirty="0" smtClean="0">
                <a:solidFill>
                  <a:prstClr val="white">
                    <a:lumMod val="65000"/>
                  </a:prstClr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de-AT" sz="1600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S3</a:t>
            </a:r>
            <a:endParaRPr lang="de-AT" sz="1600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32075" y="92918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smtClean="0">
                <a:solidFill>
                  <a:prstClr val="black"/>
                </a:solidFill>
              </a:rPr>
              <a:t>A</a:t>
            </a:r>
            <a:endParaRPr lang="de-AT" b="1" dirty="0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2075" y="269045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smtClean="0">
                <a:solidFill>
                  <a:prstClr val="black"/>
                </a:solidFill>
              </a:rPr>
              <a:t>B</a:t>
            </a:r>
            <a:endParaRPr lang="de-AT" b="1" dirty="0">
              <a:solidFill>
                <a:prstClr val="black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94119" y="4860040"/>
            <a:ext cx="5760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 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individual contribution of ASN-1 and ASN-2 to ASN100-mediated PMN protection is dependent on the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 and growth conditions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N-1 and ASN-2 were mixed at different ratios as indicated. The mAb mixtures were then serially diluted and tested for neutralization of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ulture supernatants using human PMNs to identify the limiting antibody in the mixture. Shown are the results obtained with 16-fold diluted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S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: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CH1516 strain, mAb concentration at 1:1 for RPMI-CAS is 7.8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or CCY 31.25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: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A#132 strains, mAb concentration at 1:1 for RPMI-CAS and CCY is 7.8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Data are presented as mean +/- SEM of two independent experiments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609" y="945973"/>
            <a:ext cx="5626510" cy="3649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1895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4"/>
          <p:cNvPicPr>
            <a:picLocks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640" y="796396"/>
            <a:ext cx="2667206" cy="18838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5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641" y="4695232"/>
            <a:ext cx="2664370" cy="18616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640" y="2738417"/>
            <a:ext cx="2670439" cy="19035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571591" y="1555905"/>
            <a:ext cx="2741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infected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717436" y="22315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600" dirty="0" smtClean="0">
                <a:solidFill>
                  <a:prstClr val="white">
                    <a:lumMod val="65000"/>
                  </a:prstClr>
                </a:solidFill>
                <a:latin typeface="Arial" pitchFamily="34" charset="0"/>
                <a:cs typeface="Arial" pitchFamily="34" charset="0"/>
              </a:rPr>
              <a:t>Figure S4</a:t>
            </a:r>
            <a:endParaRPr lang="de-AT" sz="1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571591" y="3535203"/>
            <a:ext cx="2741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ected - wild-type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571591" y="5482809"/>
            <a:ext cx="30978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de-AT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fected - </a:t>
            </a:r>
            <a:r>
              <a:rPr lang="el-GR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AT" sz="1000" b="1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a/hlgABC/lukED/lukSF-PV/lukGH</a:t>
            </a:r>
            <a:endParaRPr lang="en-US" sz="1000" b="1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181510" y="2509269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201220" y="4373923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201220" y="6358448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x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21010" y="6837916"/>
            <a:ext cx="5760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gocytosis of </a:t>
            </a:r>
            <a:r>
              <a:rPr lang="en-US" sz="12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 TCH1516 lacking all </a:t>
            </a:r>
            <a:r>
              <a:rPr lang="en-US" sz="1200" b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ukocidin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s and </a:t>
            </a:r>
            <a:r>
              <a:rPr lang="en-US" sz="1200" b="1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la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neutrophils were infected with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ureu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CH1516 and an isogenic gene deletion mutant lacking the genes for all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component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ukocidins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la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2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la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lgABC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kED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kSF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V/</a:t>
            </a:r>
            <a:r>
              <a:rPr lang="en-US" sz="12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kGH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t MOI 50 and visualized with May-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ünwald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iemsa staining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urs after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fection. Representative images are shown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88965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17436" y="22315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600" dirty="0" smtClean="0">
                <a:solidFill>
                  <a:prstClr val="white">
                    <a:lumMod val="65000"/>
                  </a:prstClr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de-AT" sz="1600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S5</a:t>
            </a:r>
            <a:endParaRPr lang="de-AT" sz="1600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115520" y="1163193"/>
            <a:ext cx="4741816" cy="1483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826612" y="1139534"/>
            <a:ext cx="12554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b="1" dirty="0" smtClea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CS exposed,  ASN-1</a:t>
            </a:r>
            <a:endParaRPr lang="en-US" sz="800" b="1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629675" y="2956294"/>
            <a:ext cx="1436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b="1" dirty="0" smtClea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S exposed, control mAb</a:t>
            </a:r>
            <a:endParaRPr lang="en-US" sz="800" b="1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1639999" y="1311543"/>
            <a:ext cx="4077437" cy="414430"/>
            <a:chOff x="2010776" y="611450"/>
            <a:chExt cx="3688737" cy="184666"/>
          </a:xfrm>
        </p:grpSpPr>
        <p:sp>
          <p:nvSpPr>
            <p:cNvPr id="12" name="TextBox 11"/>
            <p:cNvSpPr txBox="1"/>
            <p:nvPr/>
          </p:nvSpPr>
          <p:spPr>
            <a:xfrm>
              <a:off x="2010776" y="611450"/>
              <a:ext cx="4571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de-AT" sz="6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 gate</a:t>
              </a:r>
              <a:endParaRPr lang="en-US" sz="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184551" y="611450"/>
              <a:ext cx="909558" cy="82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6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Lymphocyte gate </a:t>
              </a:r>
              <a:endParaRPr lang="en-US" sz="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881660" y="611450"/>
              <a:ext cx="8178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6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mphocyte gate</a:t>
              </a:r>
              <a:endParaRPr lang="en-US" sz="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1115520" y="3011624"/>
            <a:ext cx="4741816" cy="1483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826612" y="2993857"/>
            <a:ext cx="12554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b="1" dirty="0" smtClea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CS exposed, ASN-2</a:t>
            </a:r>
            <a:endParaRPr lang="en-US" sz="800" b="1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1639999" y="3154921"/>
            <a:ext cx="4077437" cy="414430"/>
            <a:chOff x="2010776" y="611450"/>
            <a:chExt cx="3688737" cy="184666"/>
          </a:xfrm>
        </p:grpSpPr>
        <p:sp>
          <p:nvSpPr>
            <p:cNvPr id="18" name="TextBox 17"/>
            <p:cNvSpPr txBox="1"/>
            <p:nvPr/>
          </p:nvSpPr>
          <p:spPr>
            <a:xfrm>
              <a:off x="2010776" y="611450"/>
              <a:ext cx="4571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de-AT" sz="6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 gate</a:t>
              </a:r>
              <a:endParaRPr lang="en-US" sz="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184551" y="611450"/>
              <a:ext cx="909558" cy="82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6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Lymphocyte gate </a:t>
              </a:r>
              <a:endParaRPr lang="en-US" sz="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881660" y="611450"/>
              <a:ext cx="8178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6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mphocyte gate</a:t>
              </a:r>
              <a:endParaRPr lang="en-US" sz="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8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90" t="27071" r="29547" b="42551"/>
          <a:stretch/>
        </p:blipFill>
        <p:spPr bwMode="auto">
          <a:xfrm>
            <a:off x="759825" y="1455125"/>
            <a:ext cx="5149810" cy="1550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7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08" t="62853" r="29549" b="6320"/>
          <a:stretch/>
        </p:blipFill>
        <p:spPr bwMode="auto">
          <a:xfrm>
            <a:off x="753332" y="3302354"/>
            <a:ext cx="5154759" cy="1563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Rectangle 20"/>
          <p:cNvSpPr/>
          <p:nvPr/>
        </p:nvSpPr>
        <p:spPr>
          <a:xfrm>
            <a:off x="574348" y="5162402"/>
            <a:ext cx="5760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ction of white blood cells by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N100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ipheral WBCs were exposed to pooled BHI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lture supernatants of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ven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aureu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s for 2 hours and then stained with fluorescent antibodies specific for CD3, CD56, CD14, and CD19. Side-scatter and CD14 expression were used to discriminate lymphocyte, granulocyte and monocyte populations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ots showing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S exposed cells in presence of ASN-1 and ASN-2 (data are derived from the same experiment as shown in Fig. 6)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77938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76590" y="827480"/>
            <a:ext cx="583281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vie S1. Time lapse microscopy of ASN-1 and ASN-2 synergy in ASN100 mediated PMN protection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neutrophils were exposed to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PMI-CAS stationary CS of USA300 CA-MRSA strain TCH1516 (10x diluted) in presence of ASN-1, ASN-2, and ASN100. Survival was monitored using a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cei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M/EthD-1 LIVE/DEAD cell stain in one minute intervals for a total of 90 min (frame rate: 3 fps)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ve cells are stained green, dead cells appear in red. MAb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used at 1 µM. Live cells appear in green, dead cells in red, the last image taken at 90 min is also shown in Fig. 3B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2042059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3</Words>
  <Application>Microsoft Office PowerPoint</Application>
  <PresentationFormat>On-screen Show (4:3)</PresentationFormat>
  <Paragraphs>3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2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zter Nagy</dc:creator>
  <cp:lastModifiedBy>eszter.nagy</cp:lastModifiedBy>
  <cp:revision>1573</cp:revision>
  <cp:lastPrinted>2017-09-01T11:40:13Z</cp:lastPrinted>
  <dcterms:created xsi:type="dcterms:W3CDTF">2013-06-13T10:54:41Z</dcterms:created>
  <dcterms:modified xsi:type="dcterms:W3CDTF">2017-10-05T19:17:28Z</dcterms:modified>
</cp:coreProperties>
</file>